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8" r:id="rId2"/>
    <p:sldId id="261" r:id="rId3"/>
    <p:sldId id="263" r:id="rId4"/>
    <p:sldId id="267" r:id="rId5"/>
    <p:sldId id="289" r:id="rId6"/>
    <p:sldId id="287" r:id="rId7"/>
    <p:sldId id="288" r:id="rId8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>
      <p:cViewPr varScale="1">
        <p:scale>
          <a:sx n="64" d="100"/>
          <a:sy n="64" d="100"/>
        </p:scale>
        <p:origin x="680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FE603C-DA46-4402-A1B9-DAAF22A098EE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90832D-1258-4909-A7D6-C62574B52281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435582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5034E79-11E6-4035-8BBF-786968FF34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C0EFD2E6-1E1C-49EE-9BA2-18B62A9711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4FB6FF5-8EA3-4A9F-90F4-684828606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B17E1C0-95A9-49DF-8F44-5652DA564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DB5B076-6D3E-4A0A-952A-810C8A937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9935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F8D4E58-9834-44F1-AB55-0BC73865F5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C44E817C-8038-475E-BBC7-18DCE6A2BA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38A6DF32-62A7-4BEF-A16B-F6C0E636C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688EA7F-286C-43BB-81AE-B767C9151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4F298C2-5209-449A-A297-A9CCFAB17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21649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0F690AA1-772C-40BB-A044-14135D8C6F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EFE89F06-8719-4336-A170-4A4724ED97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3C2143F9-FAA2-4FAF-8466-8CC4D9CC17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34DF32A-904A-497B-8286-6EB8C8328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788C44C-A8F9-483B-BF91-C81D8543E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60897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F1C5F4E-DB59-4E5C-9016-87FFD44AA5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443E7EDB-E906-46DA-9A32-423740A25F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9A708F4-D3DF-468D-8C40-3B7E5F154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19DE8F70-18D3-47EA-B5D4-4C3484597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273A6852-A579-421C-A2A5-9541AE386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10341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011E24D-701E-4E68-B3F7-0B1892A7C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266CBA03-4ED7-435F-8F74-FC5DC5F4E6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C67B83F-1230-44B9-982D-396527822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388D988-BE3E-4F8D-9D70-5ED0B2ACC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5818BD1-045A-40F0-87D6-5E1258F33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54377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8B95234-24E3-448C-A61C-02CA6000C9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25CE543B-B188-4954-9D7F-40494832AD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12B2EFCA-74F5-4A0F-9401-C604DCDFC9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BE72AE27-BA42-494A-A5D7-1CDB7A5DAB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D5F1FABE-2417-4CDB-BB8D-ADF11BAE6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9ADD7967-89F3-44EE-A02F-D038845B1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75232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F2C8C51-59A8-4A65-BAB9-E6273D028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025163B2-5BF7-4BD3-B4E5-F365908A43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8A419E4E-AC94-4070-998E-7CB6592E72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94CA267E-13F1-4091-B137-DCE7CE22BB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64842EC4-C3D7-4553-A4E0-B8BB75E53F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DA7EF8F4-2117-47C6-9EF9-553BA53AE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037B4806-1753-420B-849D-37AA8831F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B125D12E-3823-41AB-95A7-5D8D656B3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47685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1C7C871-F188-4868-9A24-AF8D6CB4C1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6B2A0C99-2199-42A8-960B-8CC0737C9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5DC625FE-C9DE-47D3-BF56-3EF57DBAB3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16FC0E71-8785-4218-8CC7-EAAE062D0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80628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081F393E-5542-4790-B5E2-C1C3B0E98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C3B65888-E5FF-4556-A066-2C40157B7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BAB941DB-1A4E-410C-8A52-D7806EF7D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0400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1856879-01AF-48F0-871E-FFEECD7C8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52958FEC-6756-446E-AA9C-492DDDE919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1030E31D-EF3C-47B7-8243-CC84AB0EDE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AC6298CE-4969-467E-AE58-467715650B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0B930BA4-EF2C-49FE-9701-87EBE1A1D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A6B7424C-CD4E-4BFC-8A2D-127704C8EF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30403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FB52F1F-395C-497B-B677-34E22E6EF3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81927B61-BA3B-4214-8AC1-9E21DFE930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FBD22730-6B54-4349-8623-F114C1F8FD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B41D5465-DB01-4B97-ADB2-959F2B5044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D7FF8F1E-2C8F-48AC-AE51-131EE9E4B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5C06F073-3A44-478A-A37B-2047832F9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03588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C91EA0E4-23E7-426D-A361-76CF27CAC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C6F3BD53-6555-435A-97A9-78B9C2A0AC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A5AD502-3389-4435-B200-0C8CC21A6E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84D3A-2686-416F-A73E-508BC059D67F}" type="datetimeFigureOut">
              <a:rPr lang="zh-TW" altLang="en-US" smtClean="0"/>
              <a:t>2021/5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5A4873F-9638-4EE3-91BE-F16A59CBEC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E7D706FB-65A6-4A4E-B481-FB73033388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48C6E0-BC7D-4625-BB4E-A566D0033F4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41638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id="{BE0A07AA-70E9-4024-8281-78AA57D59EA5}"/>
              </a:ext>
            </a:extLst>
          </p:cNvPr>
          <p:cNvSpPr txBox="1"/>
          <p:nvPr/>
        </p:nvSpPr>
        <p:spPr>
          <a:xfrm>
            <a:off x="0" y="630932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b="1" dirty="0"/>
              <a:t>Figure S1 funnel plot of the primary outcome</a:t>
            </a:r>
            <a:endParaRPr lang="zh-TW" altLang="en-US" sz="2400" b="1" dirty="0"/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F90B1872-AEF6-4A38-A792-E13EAD77F5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603" t="3943" r="13179" b="2743"/>
          <a:stretch/>
        </p:blipFill>
        <p:spPr>
          <a:xfrm>
            <a:off x="805070" y="755375"/>
            <a:ext cx="9780104" cy="54168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91138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id="{FEF07F0E-5F1C-4DFD-9696-49C9F37DA4DE}"/>
              </a:ext>
            </a:extLst>
          </p:cNvPr>
          <p:cNvSpPr txBox="1"/>
          <p:nvPr/>
        </p:nvSpPr>
        <p:spPr>
          <a:xfrm>
            <a:off x="0" y="630932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b="1" dirty="0"/>
              <a:t>Figure S2A meta-regression of primary outcome and mean age</a:t>
            </a:r>
            <a:endParaRPr lang="zh-TW" altLang="en-US" sz="2400" b="1" dirty="0"/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3837B7A9-8E91-40AE-9A9C-A362B285F4B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3701" t="13043" r="3230" b="2028"/>
          <a:stretch/>
        </p:blipFill>
        <p:spPr>
          <a:xfrm>
            <a:off x="1858617" y="124950"/>
            <a:ext cx="8517836" cy="58243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9718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id="{8A342080-B551-4DA4-91B0-754E48F9E547}"/>
              </a:ext>
            </a:extLst>
          </p:cNvPr>
          <p:cNvSpPr txBox="1"/>
          <p:nvPr/>
        </p:nvSpPr>
        <p:spPr>
          <a:xfrm>
            <a:off x="0" y="630932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b="1" dirty="0"/>
              <a:t>Figure S2B meta-regression of primary outcome and female proportion</a:t>
            </a:r>
            <a:endParaRPr lang="zh-TW" altLang="en-US" sz="2400" b="1" dirty="0"/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B4C597AB-3187-43DE-92DD-0396F008ABB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4460" t="13188" r="3447" b="1739"/>
          <a:stretch/>
        </p:blipFill>
        <p:spPr>
          <a:xfrm>
            <a:off x="1928191" y="115010"/>
            <a:ext cx="8428384" cy="58342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56299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id="{52251DE6-2458-471F-97EA-F5D2ABCF2A9D}"/>
              </a:ext>
            </a:extLst>
          </p:cNvPr>
          <p:cNvSpPr txBox="1"/>
          <p:nvPr/>
        </p:nvSpPr>
        <p:spPr>
          <a:xfrm>
            <a:off x="0" y="630932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b="1" dirty="0"/>
              <a:t>Figure S2C meta-regression of primary outcome and </a:t>
            </a:r>
            <a:r>
              <a:rPr lang="en-US" altLang="zh-TW" sz="2400" b="1" dirty="0" err="1"/>
              <a:t>tDCS</a:t>
            </a:r>
            <a:r>
              <a:rPr lang="en-US" altLang="zh-TW" sz="2400" b="1" dirty="0"/>
              <a:t> current</a:t>
            </a:r>
            <a:endParaRPr lang="zh-TW" altLang="en-US" sz="2400" b="1" dirty="0"/>
          </a:p>
        </p:txBody>
      </p:sp>
      <p:pic>
        <p:nvPicPr>
          <p:cNvPr id="6" name="圖片 5">
            <a:extLst>
              <a:ext uri="{FF2B5EF4-FFF2-40B4-BE49-F238E27FC236}">
                <a16:creationId xmlns:a16="http://schemas.microsoft.com/office/drawing/2014/main" id="{0C03DE9B-297A-4FE0-9BDD-26D14C127C0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grayscl/>
          </a:blip>
          <a:srcRect l="3918" t="12608" r="3664" b="1739"/>
          <a:stretch/>
        </p:blipFill>
        <p:spPr>
          <a:xfrm>
            <a:off x="1878495" y="75254"/>
            <a:ext cx="8458201" cy="58740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04927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id="{15D28E56-EBE8-40B4-A75D-C2D7DFA6B268}"/>
              </a:ext>
            </a:extLst>
          </p:cNvPr>
          <p:cNvSpPr txBox="1"/>
          <p:nvPr/>
        </p:nvSpPr>
        <p:spPr>
          <a:xfrm>
            <a:off x="0" y="630932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b="1" dirty="0"/>
              <a:t>Figure S3 Forest plot of the surgical performance: subgroup of publication type</a:t>
            </a:r>
            <a:endParaRPr lang="zh-TW" altLang="en-US" sz="2400" b="1" dirty="0"/>
          </a:p>
        </p:txBody>
      </p:sp>
      <p:sp>
        <p:nvSpPr>
          <p:cNvPr id="119" name="Rectangle 115">
            <a:extLst>
              <a:ext uri="{FF2B5EF4-FFF2-40B4-BE49-F238E27FC236}">
                <a16:creationId xmlns:a16="http://schemas.microsoft.com/office/drawing/2014/main" id="{1ED6BDD5-429C-4331-8DB9-6CA8F204D2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27525" y="44624"/>
            <a:ext cx="150457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Statistics for each study</a:t>
            </a:r>
            <a:endParaRPr kumimoji="0" lang="zh-TW" altLang="zh-TW" sz="1200" b="0" i="0" u="sng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17" name="Rectangle 113">
            <a:extLst>
              <a:ext uri="{FF2B5EF4-FFF2-40B4-BE49-F238E27FC236}">
                <a16:creationId xmlns:a16="http://schemas.microsoft.com/office/drawing/2014/main" id="{6C0F1B0F-1DF3-4696-AD54-597E98F3B4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7267" y="44624"/>
            <a:ext cx="30457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sz="1200" b="1" i="0" u="sng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anose="020B0604020202020204" pitchFamily="34" charset="0"/>
              </a:rPr>
              <a:t>tDCS</a:t>
            </a:r>
            <a:endParaRPr kumimoji="0" lang="zh-TW" altLang="zh-TW" sz="1200" b="0" i="0" u="sng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anose="020B0604020202020204" pitchFamily="34" charset="0"/>
            </a:endParaRPr>
          </a:p>
        </p:txBody>
      </p:sp>
      <p:sp>
        <p:nvSpPr>
          <p:cNvPr id="121" name="Rectangle 117">
            <a:extLst>
              <a:ext uri="{FF2B5EF4-FFF2-40B4-BE49-F238E27FC236}">
                <a16:creationId xmlns:a16="http://schemas.microsoft.com/office/drawing/2014/main" id="{4A7EEFD4-6709-4FEA-B45C-B1F274BE5F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67665" y="44624"/>
            <a:ext cx="135287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Hedges' </a:t>
            </a:r>
            <a:r>
              <a:rPr kumimoji="0" lang="zh-TW" altLang="zh-TW" sz="1200" b="1" i="1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g</a:t>
            </a:r>
            <a:r>
              <a:rPr kumimoji="0" lang="zh-TW" altLang="zh-TW" sz="12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and 95% CI</a:t>
            </a:r>
            <a:endParaRPr kumimoji="0" lang="zh-TW" altLang="zh-TW" sz="1200" b="0" i="0" u="sng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15" name="Rectangle 111">
            <a:extLst>
              <a:ext uri="{FF2B5EF4-FFF2-40B4-BE49-F238E27FC236}">
                <a16:creationId xmlns:a16="http://schemas.microsoft.com/office/drawing/2014/main" id="{8EDFB552-46E6-4F12-BBA9-F8EB106E7F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822" y="44624"/>
            <a:ext cx="75982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sng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Study name</a:t>
            </a:r>
            <a:endParaRPr kumimoji="0" lang="zh-TW" altLang="zh-TW" sz="1200" b="0" i="0" u="sng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12" name="Rectangle 108">
            <a:extLst>
              <a:ext uri="{FF2B5EF4-FFF2-40B4-BE49-F238E27FC236}">
                <a16:creationId xmlns:a16="http://schemas.microsoft.com/office/drawing/2014/main" id="{CE7C3EF0-646E-49C2-8035-4865319E35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36" y="44624"/>
            <a:ext cx="72064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sz="12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ublication</a:t>
            </a:r>
            <a:endParaRPr kumimoji="0" lang="zh-TW" altLang="zh-TW" sz="1200" b="0" i="0" u="sng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4" name="Rectangle 130">
            <a:extLst>
              <a:ext uri="{FF2B5EF4-FFF2-40B4-BE49-F238E27FC236}">
                <a16:creationId xmlns:a16="http://schemas.microsoft.com/office/drawing/2014/main" id="{66D751D9-2A82-42C3-9586-E7B0503B05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7267" y="1061874"/>
            <a:ext cx="150239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ctive tDCS 2mA Bil PFC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7" name="Rectangle 143">
            <a:extLst>
              <a:ext uri="{FF2B5EF4-FFF2-40B4-BE49-F238E27FC236}">
                <a16:creationId xmlns:a16="http://schemas.microsoft.com/office/drawing/2014/main" id="{0E2603FB-C094-40D9-B49D-D87B02A27D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7267" y="2211735"/>
            <a:ext cx="150239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ctive tDCS 2mA Bil PFC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5" name="Rectangle 151">
            <a:extLst>
              <a:ext uri="{FF2B5EF4-FFF2-40B4-BE49-F238E27FC236}">
                <a16:creationId xmlns:a16="http://schemas.microsoft.com/office/drawing/2014/main" id="{E9E4C11B-B4BB-47C3-997F-BCF3DF5850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7267" y="2785117"/>
            <a:ext cx="116698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nodal 1mA C3/C4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3" name="Rectangle 159">
            <a:extLst>
              <a:ext uri="{FF2B5EF4-FFF2-40B4-BE49-F238E27FC236}">
                <a16:creationId xmlns:a16="http://schemas.microsoft.com/office/drawing/2014/main" id="{97B8AED7-348E-4A0E-AD0B-792123A91A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7267" y="3358498"/>
            <a:ext cx="116698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nodal 1mA C3/C4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1" name="Rectangle 167">
            <a:extLst>
              <a:ext uri="{FF2B5EF4-FFF2-40B4-BE49-F238E27FC236}">
                <a16:creationId xmlns:a16="http://schemas.microsoft.com/office/drawing/2014/main" id="{4475AB51-F243-40F2-A18A-3A28C76AE1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7267" y="3934978"/>
            <a:ext cx="116698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nodal 1mA C3/C4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9" name="Rectangle 175">
            <a:extLst>
              <a:ext uri="{FF2B5EF4-FFF2-40B4-BE49-F238E27FC236}">
                <a16:creationId xmlns:a16="http://schemas.microsoft.com/office/drawing/2014/main" id="{D1B10BD3-6E5F-4823-A4AC-4DAFA4A9CF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7267" y="4508361"/>
            <a:ext cx="59792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bMl/SMA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3" name="Rectangle 119">
            <a:extLst>
              <a:ext uri="{FF2B5EF4-FFF2-40B4-BE49-F238E27FC236}">
                <a16:creationId xmlns:a16="http://schemas.microsoft.com/office/drawing/2014/main" id="{1CD51625-DDF8-4ABB-8972-13942C5CE5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50505" y="345922"/>
            <a:ext cx="50327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Hedges'</a:t>
            </a:r>
            <a:endParaRPr kumimoji="0" lang="zh-TW" altLang="zh-TW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7" name="Rectangle 123">
            <a:extLst>
              <a:ext uri="{FF2B5EF4-FFF2-40B4-BE49-F238E27FC236}">
                <a16:creationId xmlns:a16="http://schemas.microsoft.com/office/drawing/2014/main" id="{CFC90A7B-3556-4C43-B742-30262754D5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2030" y="559778"/>
            <a:ext cx="8175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1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g</a:t>
            </a:r>
            <a:endParaRPr kumimoji="0" lang="zh-TW" altLang="zh-TW" sz="1200" b="0" i="1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5" name="Rectangle 131">
            <a:extLst>
              <a:ext uri="{FF2B5EF4-FFF2-40B4-BE49-F238E27FC236}">
                <a16:creationId xmlns:a16="http://schemas.microsoft.com/office/drawing/2014/main" id="{897F7DB7-2BF0-4266-92FD-C9D59E588D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123" y="1061874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982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1" name="Rectangle 137">
            <a:extLst>
              <a:ext uri="{FF2B5EF4-FFF2-40B4-BE49-F238E27FC236}">
                <a16:creationId xmlns:a16="http://schemas.microsoft.com/office/drawing/2014/main" id="{71DD2ABC-CB3A-4068-A933-E3F64597FB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123" y="1635255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982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8" name="Rectangle 144">
            <a:extLst>
              <a:ext uri="{FF2B5EF4-FFF2-40B4-BE49-F238E27FC236}">
                <a16:creationId xmlns:a16="http://schemas.microsoft.com/office/drawing/2014/main" id="{7C7EFC37-C8C5-4DFD-85C1-BF293EF1170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123" y="2211735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840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6" name="Rectangle 152">
            <a:extLst>
              <a:ext uri="{FF2B5EF4-FFF2-40B4-BE49-F238E27FC236}">
                <a16:creationId xmlns:a16="http://schemas.microsoft.com/office/drawing/2014/main" id="{568505AD-0372-497A-82DF-0C68FA8861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123" y="2785117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585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4" name="Rectangle 160">
            <a:extLst>
              <a:ext uri="{FF2B5EF4-FFF2-40B4-BE49-F238E27FC236}">
                <a16:creationId xmlns:a16="http://schemas.microsoft.com/office/drawing/2014/main" id="{58699EF8-182F-41AD-8B5F-59A71575E7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123" y="3358498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192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2" name="Rectangle 168">
            <a:extLst>
              <a:ext uri="{FF2B5EF4-FFF2-40B4-BE49-F238E27FC236}">
                <a16:creationId xmlns:a16="http://schemas.microsoft.com/office/drawing/2014/main" id="{B0E0DB38-FEEF-456E-A4BA-F0EEB617AD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123" y="3934978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588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0" name="Rectangle 176">
            <a:extLst>
              <a:ext uri="{FF2B5EF4-FFF2-40B4-BE49-F238E27FC236}">
                <a16:creationId xmlns:a16="http://schemas.microsoft.com/office/drawing/2014/main" id="{42C47869-9B37-4F06-939D-2C20A2A0FE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123" y="4508361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251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6" name="Rectangle 182">
            <a:extLst>
              <a:ext uri="{FF2B5EF4-FFF2-40B4-BE49-F238E27FC236}">
                <a16:creationId xmlns:a16="http://schemas.microsoft.com/office/drawing/2014/main" id="{CD93C74B-A6D9-4AA6-9DF2-31FCFD9256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01123" y="5084841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607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4" name="Rectangle 120">
            <a:extLst>
              <a:ext uri="{FF2B5EF4-FFF2-40B4-BE49-F238E27FC236}">
                <a16:creationId xmlns:a16="http://schemas.microsoft.com/office/drawing/2014/main" id="{40C51AD5-488D-4746-927C-73B284C0CE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9369" y="345922"/>
            <a:ext cx="39440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Lower</a:t>
            </a:r>
            <a:endParaRPr kumimoji="0" lang="zh-TW" altLang="zh-TW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8" name="Rectangle 124">
            <a:extLst>
              <a:ext uri="{FF2B5EF4-FFF2-40B4-BE49-F238E27FC236}">
                <a16:creationId xmlns:a16="http://schemas.microsoft.com/office/drawing/2014/main" id="{4F3843D9-7B71-4B40-8233-44144F6AA4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70422" y="559778"/>
            <a:ext cx="29334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limit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6" name="Rectangle 132">
            <a:extLst>
              <a:ext uri="{FF2B5EF4-FFF2-40B4-BE49-F238E27FC236}">
                <a16:creationId xmlns:a16="http://schemas.microsoft.com/office/drawing/2014/main" id="{E727F002-8499-40D4-AADC-24EE988D57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1110" y="1061874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242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2" name="Rectangle 138">
            <a:extLst>
              <a:ext uri="{FF2B5EF4-FFF2-40B4-BE49-F238E27FC236}">
                <a16:creationId xmlns:a16="http://schemas.microsoft.com/office/drawing/2014/main" id="{10AC9229-7D36-4A77-AA8F-363B4BEC76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1110" y="1635255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242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9" name="Rectangle 145">
            <a:extLst>
              <a:ext uri="{FF2B5EF4-FFF2-40B4-BE49-F238E27FC236}">
                <a16:creationId xmlns:a16="http://schemas.microsoft.com/office/drawing/2014/main" id="{4AC182C1-278D-49F7-9E1A-8CD49EB438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1110" y="2211735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206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7" name="Rectangle 153">
            <a:extLst>
              <a:ext uri="{FF2B5EF4-FFF2-40B4-BE49-F238E27FC236}">
                <a16:creationId xmlns:a16="http://schemas.microsoft.com/office/drawing/2014/main" id="{FA6ABD16-BB73-4E23-A720-AF652324AA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4623" y="2785117"/>
            <a:ext cx="3991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-0.237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5" name="Rectangle 161">
            <a:extLst>
              <a:ext uri="{FF2B5EF4-FFF2-40B4-BE49-F238E27FC236}">
                <a16:creationId xmlns:a16="http://schemas.microsoft.com/office/drawing/2014/main" id="{93ABE01B-993F-4003-9231-A3318A781B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1110" y="3358498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314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3" name="Rectangle 169">
            <a:extLst>
              <a:ext uri="{FF2B5EF4-FFF2-40B4-BE49-F238E27FC236}">
                <a16:creationId xmlns:a16="http://schemas.microsoft.com/office/drawing/2014/main" id="{F7730BDF-76CD-46D6-8B6C-D7B8EFEEBD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4623" y="3934978"/>
            <a:ext cx="3991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-0.041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1" name="Rectangle 177">
            <a:extLst>
              <a:ext uri="{FF2B5EF4-FFF2-40B4-BE49-F238E27FC236}">
                <a16:creationId xmlns:a16="http://schemas.microsoft.com/office/drawing/2014/main" id="{C19FD192-8AF5-4003-8B39-18E0126C3F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4623" y="4508361"/>
            <a:ext cx="3991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-0.281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7" name="Rectangle 183">
            <a:extLst>
              <a:ext uri="{FF2B5EF4-FFF2-40B4-BE49-F238E27FC236}">
                <a16:creationId xmlns:a16="http://schemas.microsoft.com/office/drawing/2014/main" id="{AF63AC6E-A140-46C5-A81A-22B5C30B29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11110" y="5084841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310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5" name="Rectangle 121">
            <a:extLst>
              <a:ext uri="{FF2B5EF4-FFF2-40B4-BE49-F238E27FC236}">
                <a16:creationId xmlns:a16="http://schemas.microsoft.com/office/drawing/2014/main" id="{91F2A3ED-85B6-4622-8EB5-953AA78380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74610" y="345922"/>
            <a:ext cx="39914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Upper</a:t>
            </a:r>
            <a:endParaRPr kumimoji="0" lang="zh-TW" altLang="zh-TW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9" name="Rectangle 125">
            <a:extLst>
              <a:ext uri="{FF2B5EF4-FFF2-40B4-BE49-F238E27FC236}">
                <a16:creationId xmlns:a16="http://schemas.microsoft.com/office/drawing/2014/main" id="{4CED50E1-8BAF-41C1-8600-EADA77116A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80409" y="559778"/>
            <a:ext cx="29334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limit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7" name="Rectangle 133">
            <a:extLst>
              <a:ext uri="{FF2B5EF4-FFF2-40B4-BE49-F238E27FC236}">
                <a16:creationId xmlns:a16="http://schemas.microsoft.com/office/drawing/2014/main" id="{91F32B07-5698-4EAE-9EE3-4082A864EA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1097" y="1061874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721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3" name="Rectangle 139">
            <a:extLst>
              <a:ext uri="{FF2B5EF4-FFF2-40B4-BE49-F238E27FC236}">
                <a16:creationId xmlns:a16="http://schemas.microsoft.com/office/drawing/2014/main" id="{E38ED358-1F0F-420F-A662-BF78C43459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1097" y="1635255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721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0" name="Rectangle 146">
            <a:extLst>
              <a:ext uri="{FF2B5EF4-FFF2-40B4-BE49-F238E27FC236}">
                <a16:creationId xmlns:a16="http://schemas.microsoft.com/office/drawing/2014/main" id="{ABABF13F-89C5-4B89-B192-316697F9C0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1097" y="2211735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475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8" name="Rectangle 154">
            <a:extLst>
              <a:ext uri="{FF2B5EF4-FFF2-40B4-BE49-F238E27FC236}">
                <a16:creationId xmlns:a16="http://schemas.microsoft.com/office/drawing/2014/main" id="{732AFB2F-EED3-42C5-9E7D-7B847AA624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1097" y="2785117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408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6" name="Rectangle 162">
            <a:extLst>
              <a:ext uri="{FF2B5EF4-FFF2-40B4-BE49-F238E27FC236}">
                <a16:creationId xmlns:a16="http://schemas.microsoft.com/office/drawing/2014/main" id="{6D480957-80FB-4CC7-946E-2BE3095510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1097" y="3358498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.070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4" name="Rectangle 170">
            <a:extLst>
              <a:ext uri="{FF2B5EF4-FFF2-40B4-BE49-F238E27FC236}">
                <a16:creationId xmlns:a16="http://schemas.microsoft.com/office/drawing/2014/main" id="{A2D44739-A11F-49CD-B774-C0BB563B44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1097" y="3934978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.216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2" name="Rectangle 178">
            <a:extLst>
              <a:ext uri="{FF2B5EF4-FFF2-40B4-BE49-F238E27FC236}">
                <a16:creationId xmlns:a16="http://schemas.microsoft.com/office/drawing/2014/main" id="{1CDFA01C-E936-424D-B019-A270805840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1097" y="4508361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782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8" name="Rectangle 184">
            <a:extLst>
              <a:ext uri="{FF2B5EF4-FFF2-40B4-BE49-F238E27FC236}">
                <a16:creationId xmlns:a16="http://schemas.microsoft.com/office/drawing/2014/main" id="{04AE2771-3A24-4387-90AE-D59C7BAD56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21097" y="5084841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904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6" name="Rectangle 122">
            <a:extLst>
              <a:ext uri="{FF2B5EF4-FFF2-40B4-BE49-F238E27FC236}">
                <a16:creationId xmlns:a16="http://schemas.microsoft.com/office/drawing/2014/main" id="{DA03FF7C-E350-4BE3-9564-0553AE83CE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8704" y="345922"/>
            <a:ext cx="51270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Relative</a:t>
            </a:r>
            <a:endParaRPr kumimoji="0" lang="zh-TW" altLang="zh-TW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1" name="Rectangle 127">
            <a:extLst>
              <a:ext uri="{FF2B5EF4-FFF2-40B4-BE49-F238E27FC236}">
                <a16:creationId xmlns:a16="http://schemas.microsoft.com/office/drawing/2014/main" id="{92D99A55-C269-4A80-8307-24867D8415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33211" y="559778"/>
            <a:ext cx="4381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weight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9" name="Rectangle 135">
            <a:extLst>
              <a:ext uri="{FF2B5EF4-FFF2-40B4-BE49-F238E27FC236}">
                <a16:creationId xmlns:a16="http://schemas.microsoft.com/office/drawing/2014/main" id="{FD275398-C58B-454F-8EB3-10F2CFC373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40200" y="1061874"/>
            <a:ext cx="4312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00.00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4" name="Rectangle 140">
            <a:extLst>
              <a:ext uri="{FF2B5EF4-FFF2-40B4-BE49-F238E27FC236}">
                <a16:creationId xmlns:a16="http://schemas.microsoft.com/office/drawing/2014/main" id="{0E95A3D2-73EF-43DD-BBDA-5C0F66903A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40200" y="1635255"/>
            <a:ext cx="4312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00.00</a:t>
            </a:r>
            <a:endParaRPr kumimoji="0" lang="zh-TW" altLang="zh-TW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2" name="Rectangle 148">
            <a:extLst>
              <a:ext uri="{FF2B5EF4-FFF2-40B4-BE49-F238E27FC236}">
                <a16:creationId xmlns:a16="http://schemas.microsoft.com/office/drawing/2014/main" id="{DF1DEF31-982A-46A6-A428-FA1DFD24D4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8747" y="2211735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1.91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0" name="Rectangle 156">
            <a:extLst>
              <a:ext uri="{FF2B5EF4-FFF2-40B4-BE49-F238E27FC236}">
                <a16:creationId xmlns:a16="http://schemas.microsoft.com/office/drawing/2014/main" id="{021C26DC-BDC6-4922-B932-87A6EA125C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8747" y="2785117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3.06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8" name="Rectangle 164">
            <a:extLst>
              <a:ext uri="{FF2B5EF4-FFF2-40B4-BE49-F238E27FC236}">
                <a16:creationId xmlns:a16="http://schemas.microsoft.com/office/drawing/2014/main" id="{363DF0F4-3497-4862-AEBC-3B67DFAA59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8747" y="3358498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1.46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6" name="Rectangle 172">
            <a:extLst>
              <a:ext uri="{FF2B5EF4-FFF2-40B4-BE49-F238E27FC236}">
                <a16:creationId xmlns:a16="http://schemas.microsoft.com/office/drawing/2014/main" id="{9216AC30-6B7F-483D-876C-06A7CB5ED6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8747" y="3934978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22.34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4" name="Rectangle 180">
            <a:extLst>
              <a:ext uri="{FF2B5EF4-FFF2-40B4-BE49-F238E27FC236}">
                <a16:creationId xmlns:a16="http://schemas.microsoft.com/office/drawing/2014/main" id="{076DC866-6F58-482C-8487-774FB083E9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8747" y="4508361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31.24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9" name="Rectangle 185">
            <a:extLst>
              <a:ext uri="{FF2B5EF4-FFF2-40B4-BE49-F238E27FC236}">
                <a16:creationId xmlns:a16="http://schemas.microsoft.com/office/drawing/2014/main" id="{8A02F381-5442-470B-A99F-641381766B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40200" y="5084841"/>
            <a:ext cx="4312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100.00</a:t>
            </a:r>
            <a:endParaRPr kumimoji="0" lang="zh-TW" altLang="zh-TW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90" name="Rectangle 186">
            <a:extLst>
              <a:ext uri="{FF2B5EF4-FFF2-40B4-BE49-F238E27FC236}">
                <a16:creationId xmlns:a16="http://schemas.microsoft.com/office/drawing/2014/main" id="{13E5D187-3F7A-4F96-B027-E45EF15869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26699" y="882112"/>
            <a:ext cx="18349" cy="4583952"/>
          </a:xfrm>
          <a:prstGeom prst="rect">
            <a:avLst/>
          </a:prstGeom>
          <a:solidFill>
            <a:srgbClr val="AFAFAF"/>
          </a:solidFill>
          <a:ln w="9525">
            <a:solidFill>
              <a:srgbClr val="AFAFA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191" name="Rectangle 187">
            <a:extLst>
              <a:ext uri="{FF2B5EF4-FFF2-40B4-BE49-F238E27FC236}">
                <a16:creationId xmlns:a16="http://schemas.microsoft.com/office/drawing/2014/main" id="{E6B6C5C8-B636-4F28-9BD4-72F8D3A517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82244" y="5662919"/>
            <a:ext cx="32380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AFAFAF"/>
                </a:solidFill>
                <a:effectLst/>
                <a:latin typeface="+mn-lt"/>
              </a:rPr>
              <a:t>-2.00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92" name="Rectangle 188">
            <a:extLst>
              <a:ext uri="{FF2B5EF4-FFF2-40B4-BE49-F238E27FC236}">
                <a16:creationId xmlns:a16="http://schemas.microsoft.com/office/drawing/2014/main" id="{673793FB-2114-4813-A92B-58BC98FB1A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75348" y="882112"/>
            <a:ext cx="20644" cy="4583952"/>
          </a:xfrm>
          <a:prstGeom prst="rect">
            <a:avLst/>
          </a:prstGeom>
          <a:solidFill>
            <a:srgbClr val="AFAFAF"/>
          </a:solidFill>
          <a:ln w="9525">
            <a:solidFill>
              <a:srgbClr val="AFAFA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193" name="Rectangle 189">
            <a:extLst>
              <a:ext uri="{FF2B5EF4-FFF2-40B4-BE49-F238E27FC236}">
                <a16:creationId xmlns:a16="http://schemas.microsoft.com/office/drawing/2014/main" id="{B9E70FC0-EE61-4476-9885-04B6642638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30894" y="5662919"/>
            <a:ext cx="32380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AFAFAF"/>
                </a:solidFill>
                <a:effectLst/>
                <a:latin typeface="+mn-lt"/>
              </a:rPr>
              <a:t>-1.00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94" name="Rectangle 190">
            <a:extLst>
              <a:ext uri="{FF2B5EF4-FFF2-40B4-BE49-F238E27FC236}">
                <a16:creationId xmlns:a16="http://schemas.microsoft.com/office/drawing/2014/main" id="{4B4EBB0D-77F4-4F01-8D72-A7C9E7E6C2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26291" y="882112"/>
            <a:ext cx="18349" cy="4583952"/>
          </a:xfrm>
          <a:prstGeom prst="rect">
            <a:avLst/>
          </a:prstGeom>
          <a:solidFill>
            <a:srgbClr val="AFAFAF"/>
          </a:solidFill>
          <a:ln w="9525">
            <a:solidFill>
              <a:srgbClr val="AFAFA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195" name="Rectangle 191">
            <a:extLst>
              <a:ext uri="{FF2B5EF4-FFF2-40B4-BE49-F238E27FC236}">
                <a16:creationId xmlns:a16="http://schemas.microsoft.com/office/drawing/2014/main" id="{7E5D4067-8042-409A-ABA7-9BA2DF006F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07068" y="5662919"/>
            <a:ext cx="2773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AFAFAF"/>
                </a:solidFill>
                <a:effectLst/>
                <a:latin typeface="+mn-lt"/>
              </a:rPr>
              <a:t>0.00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96" name="Rectangle 192">
            <a:extLst>
              <a:ext uri="{FF2B5EF4-FFF2-40B4-BE49-F238E27FC236}">
                <a16:creationId xmlns:a16="http://schemas.microsoft.com/office/drawing/2014/main" id="{15802286-690B-432E-BAD5-5822EA5656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74941" y="882112"/>
            <a:ext cx="18349" cy="4583952"/>
          </a:xfrm>
          <a:prstGeom prst="rect">
            <a:avLst/>
          </a:prstGeom>
          <a:solidFill>
            <a:srgbClr val="AFAFAF"/>
          </a:solidFill>
          <a:ln w="9525">
            <a:solidFill>
              <a:srgbClr val="AFAFA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197" name="Rectangle 193">
            <a:extLst>
              <a:ext uri="{FF2B5EF4-FFF2-40B4-BE49-F238E27FC236}">
                <a16:creationId xmlns:a16="http://schemas.microsoft.com/office/drawing/2014/main" id="{027840D9-9FDB-4A32-9DD9-7008AD46BE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55718" y="5662919"/>
            <a:ext cx="2773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AFAFAF"/>
                </a:solidFill>
                <a:effectLst/>
                <a:latin typeface="+mn-lt"/>
              </a:rPr>
              <a:t>1.00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98" name="Rectangle 194">
            <a:extLst>
              <a:ext uri="{FF2B5EF4-FFF2-40B4-BE49-F238E27FC236}">
                <a16:creationId xmlns:a16="http://schemas.microsoft.com/office/drawing/2014/main" id="{B7EB2477-9BD2-4BB9-B490-A05C2EE7D9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23591" y="882112"/>
            <a:ext cx="18349" cy="4583952"/>
          </a:xfrm>
          <a:prstGeom prst="rect">
            <a:avLst/>
          </a:prstGeom>
          <a:solidFill>
            <a:srgbClr val="AFAFAF"/>
          </a:solidFill>
          <a:ln w="9525">
            <a:solidFill>
              <a:srgbClr val="AFAFA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199" name="Rectangle 195">
            <a:extLst>
              <a:ext uri="{FF2B5EF4-FFF2-40B4-BE49-F238E27FC236}">
                <a16:creationId xmlns:a16="http://schemas.microsoft.com/office/drawing/2014/main" id="{6F45BE77-45E8-4673-AD4E-F705CFC351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06662" y="5662919"/>
            <a:ext cx="27732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AFAFAF"/>
                </a:solidFill>
                <a:effectLst/>
                <a:latin typeface="+mn-lt"/>
              </a:rPr>
              <a:t>2.00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00" name="Rectangle 196">
            <a:extLst>
              <a:ext uri="{FF2B5EF4-FFF2-40B4-BE49-F238E27FC236}">
                <a16:creationId xmlns:a16="http://schemas.microsoft.com/office/drawing/2014/main" id="{54FDD174-204C-4A47-AFB6-24EE6628E7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44188" y="1148656"/>
            <a:ext cx="1247745" cy="27895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01" name="Rectangle 197">
            <a:extLst>
              <a:ext uri="{FF2B5EF4-FFF2-40B4-BE49-F238E27FC236}">
                <a16:creationId xmlns:a16="http://schemas.microsoft.com/office/drawing/2014/main" id="{2946B3E3-5181-4D56-BEF9-0ADF5CD754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00624" y="937900"/>
            <a:ext cx="332580" cy="449408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02" name="Freeform 198">
            <a:extLst>
              <a:ext uri="{FF2B5EF4-FFF2-40B4-BE49-F238E27FC236}">
                <a16:creationId xmlns:a16="http://schemas.microsoft.com/office/drawing/2014/main" id="{6DF3B034-C8A0-41AE-8996-427871672FD9}"/>
              </a:ext>
            </a:extLst>
          </p:cNvPr>
          <p:cNvSpPr>
            <a:spLocks/>
          </p:cNvSpPr>
          <p:nvPr/>
        </p:nvSpPr>
        <p:spPr bwMode="auto">
          <a:xfrm>
            <a:off x="10444188" y="1511280"/>
            <a:ext cx="1254626" cy="461806"/>
          </a:xfrm>
          <a:custGeom>
            <a:avLst/>
            <a:gdLst>
              <a:gd name="T0" fmla="*/ 0 w 547"/>
              <a:gd name="T1" fmla="*/ 75 h 149"/>
              <a:gd name="T2" fmla="*/ 274 w 547"/>
              <a:gd name="T3" fmla="*/ 0 h 149"/>
              <a:gd name="T4" fmla="*/ 547 w 547"/>
              <a:gd name="T5" fmla="*/ 75 h 149"/>
              <a:gd name="T6" fmla="*/ 274 w 547"/>
              <a:gd name="T7" fmla="*/ 149 h 149"/>
              <a:gd name="T8" fmla="*/ 0 w 547"/>
              <a:gd name="T9" fmla="*/ 75 h 14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47" h="149">
                <a:moveTo>
                  <a:pt x="0" y="75"/>
                </a:moveTo>
                <a:lnTo>
                  <a:pt x="274" y="0"/>
                </a:lnTo>
                <a:lnTo>
                  <a:pt x="547" y="75"/>
                </a:lnTo>
                <a:lnTo>
                  <a:pt x="274" y="149"/>
                </a:lnTo>
                <a:lnTo>
                  <a:pt x="0" y="75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03" name="Rectangle 199">
            <a:extLst>
              <a:ext uri="{FF2B5EF4-FFF2-40B4-BE49-F238E27FC236}">
                <a16:creationId xmlns:a16="http://schemas.microsoft.com/office/drawing/2014/main" id="{80EE9FEA-8103-44A1-B779-5BDC8AAD8B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12077" y="2298517"/>
            <a:ext cx="1068840" cy="24795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04" name="Rectangle 200">
            <a:extLst>
              <a:ext uri="{FF2B5EF4-FFF2-40B4-BE49-F238E27FC236}">
                <a16:creationId xmlns:a16="http://schemas.microsoft.com/office/drawing/2014/main" id="{A07F9F28-BC11-40E1-A816-7785763FD4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81354" y="2087761"/>
            <a:ext cx="332580" cy="446308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05" name="Rectangle 201">
            <a:extLst>
              <a:ext uri="{FF2B5EF4-FFF2-40B4-BE49-F238E27FC236}">
                <a16:creationId xmlns:a16="http://schemas.microsoft.com/office/drawing/2014/main" id="{28A061FF-E2EF-4470-8A3F-BC3B025B6B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38212" y="2874997"/>
            <a:ext cx="1387658" cy="24795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06" name="Rectangle 202">
            <a:extLst>
              <a:ext uri="{FF2B5EF4-FFF2-40B4-BE49-F238E27FC236}">
                <a16:creationId xmlns:a16="http://schemas.microsoft.com/office/drawing/2014/main" id="{4A5DEAE7-98AD-4B92-B291-0E52CA3F6D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65751" y="2661143"/>
            <a:ext cx="330285" cy="449408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07" name="Line 203">
            <a:extLst>
              <a:ext uri="{FF2B5EF4-FFF2-40B4-BE49-F238E27FC236}">
                <a16:creationId xmlns:a16="http://schemas.microsoft.com/office/drawing/2014/main" id="{726B3228-E4BC-4372-89DD-73E001217C75}"/>
              </a:ext>
            </a:extLst>
          </p:cNvPr>
          <p:cNvSpPr>
            <a:spLocks noChangeShapeType="1"/>
          </p:cNvSpPr>
          <p:nvPr/>
        </p:nvSpPr>
        <p:spPr bwMode="auto">
          <a:xfrm>
            <a:off x="11868543" y="3312008"/>
            <a:ext cx="68809" cy="154968"/>
          </a:xfrm>
          <a:prstGeom prst="line">
            <a:avLst/>
          </a:prstGeom>
          <a:noFill/>
          <a:ln w="9525">
            <a:solidFill>
              <a:srgbClr val="5F5F5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08" name="Line 204">
            <a:extLst>
              <a:ext uri="{FF2B5EF4-FFF2-40B4-BE49-F238E27FC236}">
                <a16:creationId xmlns:a16="http://schemas.microsoft.com/office/drawing/2014/main" id="{CF6E06FA-BF35-426A-BC19-D49FDC22676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868543" y="3466977"/>
            <a:ext cx="68809" cy="151869"/>
          </a:xfrm>
          <a:prstGeom prst="line">
            <a:avLst/>
          </a:prstGeom>
          <a:noFill/>
          <a:ln w="9525">
            <a:solidFill>
              <a:srgbClr val="5F5F5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09" name="Rectangle 205">
            <a:extLst>
              <a:ext uri="{FF2B5EF4-FFF2-40B4-BE49-F238E27FC236}">
                <a16:creationId xmlns:a16="http://schemas.microsoft.com/office/drawing/2014/main" id="{F3CB9F29-A9F3-4EB3-B239-542C950CD6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06116" y="3448381"/>
            <a:ext cx="1422062" cy="24795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10" name="Rectangle 206">
            <a:extLst>
              <a:ext uri="{FF2B5EF4-FFF2-40B4-BE49-F238E27FC236}">
                <a16:creationId xmlns:a16="http://schemas.microsoft.com/office/drawing/2014/main" id="{0833B16F-4B7F-4E49-B679-633B532E91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79528" y="3237623"/>
            <a:ext cx="332580" cy="446308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11" name="Rectangle 207">
            <a:extLst>
              <a:ext uri="{FF2B5EF4-FFF2-40B4-BE49-F238E27FC236}">
                <a16:creationId xmlns:a16="http://schemas.microsoft.com/office/drawing/2014/main" id="{A628AFD4-6B57-4940-BF2E-2A1067B560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03355" y="4024861"/>
            <a:ext cx="1059665" cy="24795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12" name="Rectangle 208">
            <a:extLst>
              <a:ext uri="{FF2B5EF4-FFF2-40B4-BE49-F238E27FC236}">
                <a16:creationId xmlns:a16="http://schemas.microsoft.com/office/drawing/2014/main" id="{B2341461-9F1F-4141-A2D3-486EF26EFE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65751" y="3811004"/>
            <a:ext cx="334873" cy="449408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13" name="Rectangle 209">
            <a:extLst>
              <a:ext uri="{FF2B5EF4-FFF2-40B4-BE49-F238E27FC236}">
                <a16:creationId xmlns:a16="http://schemas.microsoft.com/office/drawing/2014/main" id="{EBDFA53A-C424-4C78-860F-EFFC8227CD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01514" y="4598241"/>
            <a:ext cx="892230" cy="21697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14" name="Rectangle 210">
            <a:extLst>
              <a:ext uri="{FF2B5EF4-FFF2-40B4-BE49-F238E27FC236}">
                <a16:creationId xmlns:a16="http://schemas.microsoft.com/office/drawing/2014/main" id="{95ACF5DD-B566-4B52-909A-F54B5EC671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81339" y="4384386"/>
            <a:ext cx="332580" cy="449408"/>
          </a:xfrm>
          <a:prstGeom prst="rect">
            <a:avLst/>
          </a:prstGeom>
          <a:solidFill>
            <a:srgbClr val="5F5F5F"/>
          </a:solidFill>
          <a:ln w="9525">
            <a:solidFill>
              <a:srgbClr val="5F5F5F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15" name="Freeform 211">
            <a:extLst>
              <a:ext uri="{FF2B5EF4-FFF2-40B4-BE49-F238E27FC236}">
                <a16:creationId xmlns:a16="http://schemas.microsoft.com/office/drawing/2014/main" id="{80C7FC7E-DF85-40DA-AE92-CD11EB772CE8}"/>
              </a:ext>
            </a:extLst>
          </p:cNvPr>
          <p:cNvSpPr>
            <a:spLocks/>
          </p:cNvSpPr>
          <p:nvPr/>
        </p:nvSpPr>
        <p:spPr bwMode="auto">
          <a:xfrm>
            <a:off x="10501529" y="4960867"/>
            <a:ext cx="504603" cy="458705"/>
          </a:xfrm>
          <a:custGeom>
            <a:avLst/>
            <a:gdLst>
              <a:gd name="T0" fmla="*/ 0 w 220"/>
              <a:gd name="T1" fmla="*/ 74 h 148"/>
              <a:gd name="T2" fmla="*/ 110 w 220"/>
              <a:gd name="T3" fmla="*/ 0 h 148"/>
              <a:gd name="T4" fmla="*/ 220 w 220"/>
              <a:gd name="T5" fmla="*/ 74 h 148"/>
              <a:gd name="T6" fmla="*/ 110 w 220"/>
              <a:gd name="T7" fmla="*/ 148 h 148"/>
              <a:gd name="T8" fmla="*/ 0 w 220"/>
              <a:gd name="T9" fmla="*/ 74 h 1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20" h="148">
                <a:moveTo>
                  <a:pt x="0" y="74"/>
                </a:moveTo>
                <a:lnTo>
                  <a:pt x="110" y="0"/>
                </a:lnTo>
                <a:lnTo>
                  <a:pt x="220" y="74"/>
                </a:lnTo>
                <a:lnTo>
                  <a:pt x="110" y="148"/>
                </a:lnTo>
                <a:lnTo>
                  <a:pt x="0" y="74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 sz="1200"/>
          </a:p>
        </p:txBody>
      </p:sp>
      <p:sp>
        <p:nvSpPr>
          <p:cNvPr id="216" name="Rectangle 212">
            <a:extLst>
              <a:ext uri="{FF2B5EF4-FFF2-40B4-BE49-F238E27FC236}">
                <a16:creationId xmlns:a16="http://schemas.microsoft.com/office/drawing/2014/main" id="{C1339D27-3C5E-4F8D-BD9C-107F6FBD7D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44272" y="5899915"/>
            <a:ext cx="13528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Better performance by sham control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17" name="Rectangle 213">
            <a:extLst>
              <a:ext uri="{FF2B5EF4-FFF2-40B4-BE49-F238E27FC236}">
                <a16:creationId xmlns:a16="http://schemas.microsoft.com/office/drawing/2014/main" id="{0ED17336-3804-46F6-824B-8AD2585672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20376" y="5899914"/>
            <a:ext cx="128898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Better performance by tDCS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3" name="Rectangle 129">
            <a:extLst>
              <a:ext uri="{FF2B5EF4-FFF2-40B4-BE49-F238E27FC236}">
                <a16:creationId xmlns:a16="http://schemas.microsoft.com/office/drawing/2014/main" id="{2FC97344-2C5C-4903-91B0-179FBCDCFB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822" y="1061874"/>
            <a:ext cx="94974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atel, R. (2020)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6" name="Rectangle 142">
            <a:extLst>
              <a:ext uri="{FF2B5EF4-FFF2-40B4-BE49-F238E27FC236}">
                <a16:creationId xmlns:a16="http://schemas.microsoft.com/office/drawing/2014/main" id="{5FAC836D-137E-4186-8595-F2889EAFA4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822" y="2211735"/>
            <a:ext cx="112947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shcroft, J. (2020)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4" name="Rectangle 150">
            <a:extLst>
              <a:ext uri="{FF2B5EF4-FFF2-40B4-BE49-F238E27FC236}">
                <a16:creationId xmlns:a16="http://schemas.microsoft.com/office/drawing/2014/main" id="{4A2B7B3B-A70E-4A14-B41E-50D6F8A79F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822" y="2785117"/>
            <a:ext cx="127560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Ciechanski, P. (2017)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2" name="Rectangle 158">
            <a:extLst>
              <a:ext uri="{FF2B5EF4-FFF2-40B4-BE49-F238E27FC236}">
                <a16:creationId xmlns:a16="http://schemas.microsoft.com/office/drawing/2014/main" id="{2B933845-6A1C-4E19-B148-4BC77A4C08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822" y="3358498"/>
            <a:ext cx="127560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Ciechanski, P. (2019)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0" name="Rectangle 166">
            <a:extLst>
              <a:ext uri="{FF2B5EF4-FFF2-40B4-BE49-F238E27FC236}">
                <a16:creationId xmlns:a16="http://schemas.microsoft.com/office/drawing/2014/main" id="{1440693D-3368-4B38-B340-0DA388EA2B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822" y="3934978"/>
            <a:ext cx="127560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Ciechanski, P. (2018)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8" name="Rectangle 174">
            <a:extLst>
              <a:ext uri="{FF2B5EF4-FFF2-40B4-BE49-F238E27FC236}">
                <a16:creationId xmlns:a16="http://schemas.microsoft.com/office/drawing/2014/main" id="{D441483B-1AFC-4551-83D6-4B956B5989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822" y="4508361"/>
            <a:ext cx="10164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Cox, M.L. (2020)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5" name="Rectangle 181">
            <a:extLst>
              <a:ext uri="{FF2B5EF4-FFF2-40B4-BE49-F238E27FC236}">
                <a16:creationId xmlns:a16="http://schemas.microsoft.com/office/drawing/2014/main" id="{22597139-D032-4D07-A3BB-EED7B1854D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822" y="5084841"/>
            <a:ext cx="8876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rticle</a:t>
            </a:r>
            <a:r>
              <a:rPr kumimoji="0" lang="en-US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overall</a:t>
            </a:r>
            <a:endParaRPr kumimoji="0" lang="zh-TW" altLang="zh-TW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20" name="Rectangle 136">
            <a:extLst>
              <a:ext uri="{FF2B5EF4-FFF2-40B4-BE49-F238E27FC236}">
                <a16:creationId xmlns:a16="http://schemas.microsoft.com/office/drawing/2014/main" id="{1210A8E0-4E17-465B-8D9A-8D81AB3D14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822" y="1635255"/>
            <a:ext cx="100033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bstract</a:t>
            </a:r>
            <a:r>
              <a:rPr kumimoji="0" lang="en-US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overall</a:t>
            </a:r>
            <a:endParaRPr kumimoji="0" lang="zh-TW" altLang="zh-TW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2" name="Rectangle 128">
            <a:extLst>
              <a:ext uri="{FF2B5EF4-FFF2-40B4-BE49-F238E27FC236}">
                <a16:creationId xmlns:a16="http://schemas.microsoft.com/office/drawing/2014/main" id="{B1C29C08-78FA-4BA8-8432-6EA42DB428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36" y="1061874"/>
            <a:ext cx="52014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bstract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0" name="Rectangle 136">
            <a:extLst>
              <a:ext uri="{FF2B5EF4-FFF2-40B4-BE49-F238E27FC236}">
                <a16:creationId xmlns:a16="http://schemas.microsoft.com/office/drawing/2014/main" id="{5A7F5A6F-9712-4DC3-B0D5-10DF759305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36" y="1635255"/>
            <a:ext cx="53110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bstract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45" name="Rectangle 141">
            <a:extLst>
              <a:ext uri="{FF2B5EF4-FFF2-40B4-BE49-F238E27FC236}">
                <a16:creationId xmlns:a16="http://schemas.microsoft.com/office/drawing/2014/main" id="{60836817-0398-4B59-B1C2-D37CA04A9F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36" y="2211735"/>
            <a:ext cx="40716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rticle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3" name="Rectangle 149">
            <a:extLst>
              <a:ext uri="{FF2B5EF4-FFF2-40B4-BE49-F238E27FC236}">
                <a16:creationId xmlns:a16="http://schemas.microsoft.com/office/drawing/2014/main" id="{0A3BEFE9-3130-48E3-AA2D-454E48CD3D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36" y="2785117"/>
            <a:ext cx="40716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rticle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1" name="Rectangle 157">
            <a:extLst>
              <a:ext uri="{FF2B5EF4-FFF2-40B4-BE49-F238E27FC236}">
                <a16:creationId xmlns:a16="http://schemas.microsoft.com/office/drawing/2014/main" id="{212B054B-843C-4B9A-B006-C9535CF036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36" y="3358498"/>
            <a:ext cx="40716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rticle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9" name="Rectangle 165">
            <a:extLst>
              <a:ext uri="{FF2B5EF4-FFF2-40B4-BE49-F238E27FC236}">
                <a16:creationId xmlns:a16="http://schemas.microsoft.com/office/drawing/2014/main" id="{17199043-E85E-4EBB-A125-7334EAD586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36" y="3934978"/>
            <a:ext cx="40716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rticle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7" name="Rectangle 173">
            <a:extLst>
              <a:ext uri="{FF2B5EF4-FFF2-40B4-BE49-F238E27FC236}">
                <a16:creationId xmlns:a16="http://schemas.microsoft.com/office/drawing/2014/main" id="{B1B6BE67-F209-45B0-AA1E-588DB3DC11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36" y="4508361"/>
            <a:ext cx="40716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rticle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22" name="Rectangle 181">
            <a:extLst>
              <a:ext uri="{FF2B5EF4-FFF2-40B4-BE49-F238E27FC236}">
                <a16:creationId xmlns:a16="http://schemas.microsoft.com/office/drawing/2014/main" id="{48DA3AFB-B3DE-472C-9A5B-12DF8E0D69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36" y="5084841"/>
            <a:ext cx="41838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rticle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0" name="Rectangle 126">
            <a:extLst>
              <a:ext uri="{FF2B5EF4-FFF2-40B4-BE49-F238E27FC236}">
                <a16:creationId xmlns:a16="http://schemas.microsoft.com/office/drawing/2014/main" id="{0C7226A5-C0D5-440E-BADF-C32E65F43A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84597" y="559778"/>
            <a:ext cx="46326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TW" sz="12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p v</a:t>
            </a:r>
            <a:r>
              <a:rPr kumimoji="0" lang="zh-TW" altLang="zh-TW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alue</a:t>
            </a:r>
            <a:endParaRPr kumimoji="0" lang="zh-TW" altLang="zh-TW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38" name="Rectangle 134">
            <a:extLst>
              <a:ext uri="{FF2B5EF4-FFF2-40B4-BE49-F238E27FC236}">
                <a16:creationId xmlns:a16="http://schemas.microsoft.com/office/drawing/2014/main" id="{90309BFC-03E3-4E64-A735-17BD351F9B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204" y="1061874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09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1" name="Rectangle 147">
            <a:extLst>
              <a:ext uri="{FF2B5EF4-FFF2-40B4-BE49-F238E27FC236}">
                <a16:creationId xmlns:a16="http://schemas.microsoft.com/office/drawing/2014/main" id="{79282DE0-44C2-4721-BAD3-483E8AB7CC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204" y="2211735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09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59" name="Rectangle 155">
            <a:extLst>
              <a:ext uri="{FF2B5EF4-FFF2-40B4-BE49-F238E27FC236}">
                <a16:creationId xmlns:a16="http://schemas.microsoft.com/office/drawing/2014/main" id="{BA16B14B-9A75-4186-B2C6-19B3D78D23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204" y="2785117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163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67" name="Rectangle 163">
            <a:extLst>
              <a:ext uri="{FF2B5EF4-FFF2-40B4-BE49-F238E27FC236}">
                <a16:creationId xmlns:a16="http://schemas.microsoft.com/office/drawing/2014/main" id="{2BFCB47D-362B-452A-8198-F4F5118215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204" y="3358498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08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75" name="Rectangle 171">
            <a:extLst>
              <a:ext uri="{FF2B5EF4-FFF2-40B4-BE49-F238E27FC236}">
                <a16:creationId xmlns:a16="http://schemas.microsoft.com/office/drawing/2014/main" id="{40808C0C-8E02-47DA-BFAC-D0C2931571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204" y="3934978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67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83" name="Rectangle 179">
            <a:extLst>
              <a:ext uri="{FF2B5EF4-FFF2-40B4-BE49-F238E27FC236}">
                <a16:creationId xmlns:a16="http://schemas.microsoft.com/office/drawing/2014/main" id="{14E178A9-A5D6-420A-AB58-60A2499462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204" y="4508361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356</a:t>
            </a:r>
            <a:endParaRPr kumimoji="0" lang="zh-TW" altLang="zh-TW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24" name="Rectangle 185">
            <a:extLst>
              <a:ext uri="{FF2B5EF4-FFF2-40B4-BE49-F238E27FC236}">
                <a16:creationId xmlns:a16="http://schemas.microsoft.com/office/drawing/2014/main" id="{ABBF8CAC-47AB-49EC-BC2F-24C1B6865B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204" y="5084841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00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225" name="Rectangle 140">
            <a:extLst>
              <a:ext uri="{FF2B5EF4-FFF2-40B4-BE49-F238E27FC236}">
                <a16:creationId xmlns:a16="http://schemas.microsoft.com/office/drawing/2014/main" id="{C6F243E3-8484-46F7-90D8-4038601E3C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95204" y="1635255"/>
            <a:ext cx="35266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0.009</a:t>
            </a:r>
            <a:endParaRPr kumimoji="0" lang="zh-TW" altLang="zh-TW" sz="12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2458962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>
            <a:extLst>
              <a:ext uri="{FF2B5EF4-FFF2-40B4-BE49-F238E27FC236}">
                <a16:creationId xmlns:a16="http://schemas.microsoft.com/office/drawing/2014/main" id="{BF3CFBF3-F3DF-4BF2-ABFF-68D6CE5ADBE3}"/>
              </a:ext>
            </a:extLst>
          </p:cNvPr>
          <p:cNvSpPr txBox="1"/>
          <p:nvPr/>
        </p:nvSpPr>
        <p:spPr>
          <a:xfrm>
            <a:off x="0" y="6371589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b="1" dirty="0"/>
              <a:t>Figure S4A overview of risk of bias</a:t>
            </a:r>
            <a:endParaRPr lang="zh-TW" altLang="en-US" sz="2400" b="1" dirty="0"/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57AA00ED-5FD2-450B-B5E8-AC236A2720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9516" y="1340768"/>
            <a:ext cx="8712968" cy="3680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342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">
            <a:extLst>
              <a:ext uri="{FF2B5EF4-FFF2-40B4-BE49-F238E27FC236}">
                <a16:creationId xmlns:a16="http://schemas.microsoft.com/office/drawing/2014/main" id="{E318C0F2-060A-4E6B-A9C3-9C4B6C3EF157}"/>
              </a:ext>
            </a:extLst>
          </p:cNvPr>
          <p:cNvSpPr txBox="1"/>
          <p:nvPr/>
        </p:nvSpPr>
        <p:spPr>
          <a:xfrm>
            <a:off x="1" y="6361450"/>
            <a:ext cx="7680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2400" b="1"/>
              <a:t>Figure S4B </a:t>
            </a:r>
            <a:r>
              <a:rPr lang="en-US" altLang="zh-TW" sz="2400" b="1" dirty="0"/>
              <a:t>detailed risk of bias in each study</a:t>
            </a:r>
            <a:endParaRPr lang="zh-TW" altLang="en-US" sz="2400" b="1" dirty="0"/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71BACE20-915C-4B73-94BE-CE9D1AE9EC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2144" y="188640"/>
            <a:ext cx="4442445" cy="6556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5797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2</Words>
  <Application>Microsoft Office PowerPoint</Application>
  <PresentationFormat>寬螢幕</PresentationFormat>
  <Paragraphs>90</Paragraphs>
  <Slides>7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Ping-Tao Tseng</dc:creator>
  <cp:lastModifiedBy>Ping-Tao Tseng</cp:lastModifiedBy>
  <cp:revision>32</cp:revision>
  <dcterms:created xsi:type="dcterms:W3CDTF">2020-09-26T08:28:24Z</dcterms:created>
  <dcterms:modified xsi:type="dcterms:W3CDTF">2021-05-25T15:42:50Z</dcterms:modified>
</cp:coreProperties>
</file>